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145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C0B8F-592C-455C-8313-C561C5F0D003}" type="datetimeFigureOut">
              <a:rPr lang="en-US" smtClean="0"/>
              <a:t>5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3951B-6B7F-4DAE-BC50-74AA5F4CA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894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C0B8F-592C-455C-8313-C561C5F0D003}" type="datetimeFigureOut">
              <a:rPr lang="en-US" smtClean="0"/>
              <a:t>5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3951B-6B7F-4DAE-BC50-74AA5F4CA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418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C0B8F-592C-455C-8313-C561C5F0D003}" type="datetimeFigureOut">
              <a:rPr lang="en-US" smtClean="0"/>
              <a:t>5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3951B-6B7F-4DAE-BC50-74AA5F4CA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513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C0B8F-592C-455C-8313-C561C5F0D003}" type="datetimeFigureOut">
              <a:rPr lang="en-US" smtClean="0"/>
              <a:t>5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3951B-6B7F-4DAE-BC50-74AA5F4CA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998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C0B8F-592C-455C-8313-C561C5F0D003}" type="datetimeFigureOut">
              <a:rPr lang="en-US" smtClean="0"/>
              <a:t>5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3951B-6B7F-4DAE-BC50-74AA5F4CA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294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C0B8F-592C-455C-8313-C561C5F0D003}" type="datetimeFigureOut">
              <a:rPr lang="en-US" smtClean="0"/>
              <a:t>5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3951B-6B7F-4DAE-BC50-74AA5F4CA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8243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C0B8F-592C-455C-8313-C561C5F0D003}" type="datetimeFigureOut">
              <a:rPr lang="en-US" smtClean="0"/>
              <a:t>5/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3951B-6B7F-4DAE-BC50-74AA5F4CA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136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C0B8F-592C-455C-8313-C561C5F0D003}" type="datetimeFigureOut">
              <a:rPr lang="en-US" smtClean="0"/>
              <a:t>5/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3951B-6B7F-4DAE-BC50-74AA5F4CA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324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C0B8F-592C-455C-8313-C561C5F0D003}" type="datetimeFigureOut">
              <a:rPr lang="en-US" smtClean="0"/>
              <a:t>5/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3951B-6B7F-4DAE-BC50-74AA5F4CA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372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C0B8F-592C-455C-8313-C561C5F0D003}" type="datetimeFigureOut">
              <a:rPr lang="en-US" smtClean="0"/>
              <a:t>5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3951B-6B7F-4DAE-BC50-74AA5F4CA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1105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C0B8F-592C-455C-8313-C561C5F0D003}" type="datetimeFigureOut">
              <a:rPr lang="en-US" smtClean="0"/>
              <a:t>5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3951B-6B7F-4DAE-BC50-74AA5F4CA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439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2C0B8F-592C-455C-8313-C561C5F0D003}" type="datetimeFigureOut">
              <a:rPr lang="en-US" smtClean="0"/>
              <a:t>5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63951B-6B7F-4DAE-BC50-74AA5F4CA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8991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tiff"/><Relationship Id="rId5" Type="http://schemas.microsoft.com/office/2007/relationships/hdphoto" Target="../media/hdphoto1.wdp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9721688"/>
              </p:ext>
            </p:extLst>
          </p:nvPr>
        </p:nvGraphicFramePr>
        <p:xfrm>
          <a:off x="329184" y="1484863"/>
          <a:ext cx="8311896" cy="362663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17904">
                  <a:extLst>
                    <a:ext uri="{9D8B030D-6E8A-4147-A177-3AD203B41FA5}">
                      <a16:colId xmlns:a16="http://schemas.microsoft.com/office/drawing/2014/main" val="2446902111"/>
                    </a:ext>
                  </a:extLst>
                </a:gridCol>
                <a:gridCol w="1987698">
                  <a:extLst>
                    <a:ext uri="{9D8B030D-6E8A-4147-A177-3AD203B41FA5}">
                      <a16:colId xmlns:a16="http://schemas.microsoft.com/office/drawing/2014/main" val="881850380"/>
                    </a:ext>
                  </a:extLst>
                </a:gridCol>
                <a:gridCol w="817196">
                  <a:extLst>
                    <a:ext uri="{9D8B030D-6E8A-4147-A177-3AD203B41FA5}">
                      <a16:colId xmlns:a16="http://schemas.microsoft.com/office/drawing/2014/main" val="3966733968"/>
                    </a:ext>
                  </a:extLst>
                </a:gridCol>
                <a:gridCol w="817196">
                  <a:extLst>
                    <a:ext uri="{9D8B030D-6E8A-4147-A177-3AD203B41FA5}">
                      <a16:colId xmlns:a16="http://schemas.microsoft.com/office/drawing/2014/main" val="1305046606"/>
                    </a:ext>
                  </a:extLst>
                </a:gridCol>
                <a:gridCol w="1718007">
                  <a:extLst>
                    <a:ext uri="{9D8B030D-6E8A-4147-A177-3AD203B41FA5}">
                      <a16:colId xmlns:a16="http://schemas.microsoft.com/office/drawing/2014/main" val="3861663025"/>
                    </a:ext>
                  </a:extLst>
                </a:gridCol>
                <a:gridCol w="1453895">
                  <a:extLst>
                    <a:ext uri="{9D8B030D-6E8A-4147-A177-3AD203B41FA5}">
                      <a16:colId xmlns:a16="http://schemas.microsoft.com/office/drawing/2014/main" val="2518035288"/>
                    </a:ext>
                  </a:extLst>
                </a:gridCol>
              </a:tblGrid>
              <a:tr h="254982">
                <a:tc rowSpan="2"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ebrafish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solidFill>
                            <a:schemeClr val="lt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ouse</a:t>
                      </a:r>
                    </a:p>
                  </a:txBody>
                  <a:tcPr marL="68580" marR="68580" marT="0" marB="0"/>
                </a:tc>
                <a:tc rowSpan="2"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solidFill>
                            <a:schemeClr val="lt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uman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69384653"/>
                  </a:ext>
                </a:extLst>
              </a:tr>
              <a:tr h="254982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VP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CM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accent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13700123"/>
                  </a:ext>
                </a:extLst>
              </a:tr>
              <a:tr h="288076">
                <a:tc rowSpan="5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800" b="1" kern="1200" dirty="0" smtClean="0">
                        <a:solidFill>
                          <a:schemeClr val="lt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800" b="1" kern="1200" dirty="0" smtClean="0">
                        <a:solidFill>
                          <a:schemeClr val="lt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1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athology</a:t>
                      </a:r>
                      <a:endParaRPr lang="en-US" sz="1800" b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Multi-cavernous </a:t>
                      </a:r>
                      <a:r>
                        <a:rPr lang="en-US" sz="1100" dirty="0" smtClean="0">
                          <a:effectLst/>
                        </a:rPr>
                        <a:t>Malformation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 </a:t>
                      </a:r>
                      <a:r>
                        <a:rPr lang="en-US" sz="1100" dirty="0" smtClean="0">
                          <a:effectLst/>
                        </a:rPr>
                        <a:t>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60123769"/>
                  </a:ext>
                </a:extLst>
              </a:tr>
              <a:tr h="29009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Perilesional Iron Deposition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yes1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62817951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Sluggish Blood Flow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yes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?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21252458"/>
                  </a:ext>
                </a:extLst>
              </a:tr>
              <a:tr h="5861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Widely Distribution </a:t>
                      </a:r>
                      <a:r>
                        <a:rPr lang="en-US" sz="1100" dirty="0">
                          <a:effectLst/>
                        </a:rPr>
                        <a:t>in </a:t>
                      </a:r>
                      <a:r>
                        <a:rPr lang="en-US" sz="1100" dirty="0" smtClean="0">
                          <a:effectLst/>
                        </a:rPr>
                        <a:t>Brain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+mn-lt"/>
                          <a:ea typeface="+mn-ea"/>
                          <a:cs typeface="+mn-cs"/>
                        </a:rPr>
                        <a:t>_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only in </a:t>
                      </a:r>
                      <a:r>
                        <a:rPr lang="en-US" sz="1100" dirty="0" smtClean="0">
                          <a:effectLst/>
                        </a:rPr>
                        <a:t>cerebellum </a:t>
                      </a:r>
                      <a:r>
                        <a:rPr lang="en-US" sz="1100" dirty="0">
                          <a:effectLst/>
                        </a:rPr>
                        <a:t>in acute model; yes in chronic </a:t>
                      </a:r>
                      <a:r>
                        <a:rPr lang="en-US" sz="1100" dirty="0" smtClean="0">
                          <a:effectLst/>
                        </a:rPr>
                        <a:t>model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30892110"/>
                  </a:ext>
                </a:extLst>
              </a:tr>
              <a:tr h="27921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</a:rPr>
                        <a:t>Extracranial</a:t>
                      </a:r>
                      <a:r>
                        <a:rPr lang="en-US" sz="1100" dirty="0">
                          <a:effectLst/>
                        </a:rPr>
                        <a:t> lesion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+mn-lt"/>
                          <a:ea typeface="+mn-ea"/>
                          <a:cs typeface="+mn-cs"/>
                        </a:rPr>
                        <a:t>_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Not reported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99875260"/>
                  </a:ext>
                </a:extLst>
              </a:tr>
              <a:tr h="565881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tics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Mosaic inactivation of CCM gen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an-endothelial</a:t>
                      </a:r>
                      <a:r>
                        <a:rPr lang="en-US" sz="1100" baseline="0" dirty="0" smtClean="0"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inactivation in acute model; yes in chronic model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33452001"/>
                  </a:ext>
                </a:extLst>
              </a:tr>
              <a:tr h="2672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Dependent on mekk3-klf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</a:rPr>
                        <a:t>yes</a:t>
                      </a:r>
                      <a:endParaRPr lang="en-US" sz="1100" dirty="0" smtClean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?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31866353"/>
                  </a:ext>
                </a:extLst>
              </a:tr>
              <a:tr h="296791">
                <a:tc rowSpan="2"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esponse to chemicals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ROCK inhibito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?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?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60165044"/>
                  </a:ext>
                </a:extLst>
              </a:tr>
              <a:tr h="2358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propranolo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+mn-lt"/>
                          <a:ea typeface="+mn-ea"/>
                          <a:cs typeface="+mn-cs"/>
                        </a:rPr>
                        <a:t>?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74831541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29183" y="545123"/>
            <a:ext cx="2730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Table 1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38799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29183" y="545123"/>
            <a:ext cx="2730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Table 2. </a:t>
            </a:r>
            <a:endParaRPr lang="en-US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660966" y="1503483"/>
          <a:ext cx="6368064" cy="316480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5604">
                  <a:extLst>
                    <a:ext uri="{9D8B030D-6E8A-4147-A177-3AD203B41FA5}">
                      <a16:colId xmlns:a16="http://schemas.microsoft.com/office/drawing/2014/main" val="3298146596"/>
                    </a:ext>
                  </a:extLst>
                </a:gridCol>
                <a:gridCol w="1645066">
                  <a:extLst>
                    <a:ext uri="{9D8B030D-6E8A-4147-A177-3AD203B41FA5}">
                      <a16:colId xmlns:a16="http://schemas.microsoft.com/office/drawing/2014/main" val="2352403644"/>
                    </a:ext>
                  </a:extLst>
                </a:gridCol>
                <a:gridCol w="743019">
                  <a:extLst>
                    <a:ext uri="{9D8B030D-6E8A-4147-A177-3AD203B41FA5}">
                      <a16:colId xmlns:a16="http://schemas.microsoft.com/office/drawing/2014/main" val="2959580187"/>
                    </a:ext>
                  </a:extLst>
                </a:gridCol>
                <a:gridCol w="478381">
                  <a:extLst>
                    <a:ext uri="{9D8B030D-6E8A-4147-A177-3AD203B41FA5}">
                      <a16:colId xmlns:a16="http://schemas.microsoft.com/office/drawing/2014/main" val="645901224"/>
                    </a:ext>
                  </a:extLst>
                </a:gridCol>
                <a:gridCol w="508916">
                  <a:extLst>
                    <a:ext uri="{9D8B030D-6E8A-4147-A177-3AD203B41FA5}">
                      <a16:colId xmlns:a16="http://schemas.microsoft.com/office/drawing/2014/main" val="3467390585"/>
                    </a:ext>
                  </a:extLst>
                </a:gridCol>
                <a:gridCol w="1368868">
                  <a:extLst>
                    <a:ext uri="{9D8B030D-6E8A-4147-A177-3AD203B41FA5}">
                      <a16:colId xmlns:a16="http://schemas.microsoft.com/office/drawing/2014/main" val="237291204"/>
                    </a:ext>
                  </a:extLst>
                </a:gridCol>
                <a:gridCol w="1418210">
                  <a:extLst>
                    <a:ext uri="{9D8B030D-6E8A-4147-A177-3AD203B41FA5}">
                      <a16:colId xmlns:a16="http://schemas.microsoft.com/office/drawing/2014/main" val="3198805383"/>
                    </a:ext>
                  </a:extLst>
                </a:gridCol>
              </a:tblGrid>
              <a:tr h="184638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NA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hromosom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osi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irec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Forward Primer (5'-3'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everse Primer (5'-3'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3175765961"/>
                  </a:ext>
                </a:extLst>
              </a:tr>
              <a:tr h="158263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gTAAA-GCGCCAaGGG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237149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-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TTTCTGCAGACCCTATGA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CGGAAACTACAATTCCCA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3321834187"/>
                  </a:ext>
                </a:extLst>
              </a:tr>
              <a:tr h="13888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CTAAACGCaCC-tGGG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97672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-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GATCCTTCTTCATCAGTG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TAGGTCTGCCTGCCACAA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310200807"/>
                  </a:ext>
                </a:extLst>
              </a:tr>
              <a:tr h="13888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>
                          <a:effectLst/>
                        </a:rPr>
                        <a:t>ACgCTAAA-GgGCCACGGGG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64084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-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GCCCAGGTAATAGGCTA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CACCTCACGACCATCTG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564507216"/>
                  </a:ext>
                </a:extLst>
              </a:tr>
              <a:tr h="167438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>
                          <a:effectLst/>
                        </a:rPr>
                        <a:t>ACTgTAAACGgGCCA</a:t>
                      </a:r>
                      <a:r>
                        <a:rPr lang="en-US" sz="900" u="none" strike="noStrike" dirty="0">
                          <a:effectLst/>
                        </a:rPr>
                        <a:t>-GGCG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741805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AAGCCTCCAACTCCAG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AGGGCGAAATGAAAGCGG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3985755466"/>
                  </a:ext>
                </a:extLst>
              </a:tr>
              <a:tr h="16215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gTAAACGgGCCA-GGC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56910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ACTCCAGCTGACGCAGCT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GCGAAATGAAAGCGGTG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2696151205"/>
                  </a:ext>
                </a:extLst>
              </a:tr>
              <a:tr h="145083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CTAAATaGgGCCACGGT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53327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-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AAAACAGTGCTGCCTGC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TTATCTAGCGCTCACGGA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2913502439"/>
                  </a:ext>
                </a:extLst>
              </a:tr>
              <a:tr h="162150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CTAAATaGgGCCACGGG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10873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-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GAGCAGCAGATGGCTCTG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GCCTTTACGATAGCCAG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3674996640"/>
                  </a:ext>
                </a:extLst>
              </a:tr>
              <a:tr h="13888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CTAAACTGCagCACGGC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7990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-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TGCGTTTATATGAGACGG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AGAGGATCTTGTTCCCG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2255863349"/>
                  </a:ext>
                </a:extLst>
              </a:tr>
              <a:tr h="13888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CT-TAAACcCGCCACGGT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21236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-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CGCAAACTCCTTCAGGCG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TCTGTCCTCTGCGTGTA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2580387045"/>
                  </a:ext>
                </a:extLst>
              </a:tr>
              <a:tr h="157486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gTAAACGgGCCA-GGC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155575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-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AGGGCGAAATGAAAGCGG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GCTGACGCAGCTTCAC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1433964807"/>
                  </a:ext>
                </a:extLst>
              </a:tr>
              <a:tr h="13888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gTAAACGgGCCA-GGC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13070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AGGTGGTTGAGGTTGGA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AAGGCAAGCCAACACTG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2987788373"/>
                  </a:ext>
                </a:extLst>
              </a:tr>
              <a:tr h="13888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gTAAACGgGCCA-GGC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939733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TGACGCAGCTTCACCTCT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CAAGCCAACACTGTCAC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663265618"/>
                  </a:ext>
                </a:extLst>
              </a:tr>
              <a:tr h="140417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tTCTAAACGaGCCACGAGA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28557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-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GACTCACAGTGCAT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CATACACCTCTAGTGTCC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72987632"/>
                  </a:ext>
                </a:extLst>
              </a:tr>
              <a:tr h="13888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gTAAA-GCtCCACGGT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51298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-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TGTAGTTCTTGTGGTAC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CTTCTCCATGTCTCTGTA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2462807827"/>
                  </a:ext>
                </a:extLst>
              </a:tr>
              <a:tr h="13888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CTAAACG-GCCAtGtT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43605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-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GGCTCTCCAAATTTGA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CTCAGAAGGTCGAACT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132412799"/>
                  </a:ext>
                </a:extLst>
              </a:tr>
              <a:tr h="13888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gTAAACGgGCCA-GGC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334553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-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AAGCCAACACTGTCAC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AAGCCTCCAACTCCAG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2350495527"/>
                  </a:ext>
                </a:extLst>
              </a:tr>
              <a:tr h="13888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gTAAACGgGCCA-GGC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5659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AAGGTGGTTGAGGTTGGA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CGAAATGAAAGCGGTG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2315203832"/>
                  </a:ext>
                </a:extLst>
              </a:tr>
              <a:tr h="13888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CTAAAC-aGCCAgGGG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388884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ATCCTGGTTGAAGTCAGA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CACTTTGGCAGGACACA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4135027317"/>
                  </a:ext>
                </a:extLst>
              </a:tr>
              <a:tr h="167557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>
                          <a:effectLst/>
                        </a:rPr>
                        <a:t>ACTCTAAAaG-GCCACaGAG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58095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GGAAGGAAGCCTGGAGA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ACACCAAACTTTGATCGG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3162822852"/>
                  </a:ext>
                </a:extLst>
              </a:tr>
              <a:tr h="126409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gTAAACGgGCCA-GGC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511169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AAGCCTCCAACTCCAG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AAGGGCGAAATGAAAGCGG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20" marR="5920" marT="5920" marB="0" anchor="b"/>
                </a:tc>
                <a:extLst>
                  <a:ext uri="{0D108BD9-81ED-4DB2-BD59-A6C34878D82A}">
                    <a16:rowId xmlns:a16="http://schemas.microsoft.com/office/drawing/2014/main" val="9478210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889805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8878"/>
          <a:stretch/>
        </p:blipFill>
        <p:spPr>
          <a:xfrm>
            <a:off x="1863475" y="950908"/>
            <a:ext cx="3647106" cy="2316168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365760" y="317082"/>
            <a:ext cx="863193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</a:t>
            </a:r>
            <a:r>
              <a:rPr lang="en-US" dirty="0" smtClean="0"/>
              <a:t>Figure 1. 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34" r="2555" b="10027"/>
          <a:stretch/>
        </p:blipFill>
        <p:spPr>
          <a:xfrm>
            <a:off x="5592328" y="1110212"/>
            <a:ext cx="3260035" cy="217059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6671385" y="2064588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482425" y="3199641"/>
            <a:ext cx="7718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adrb1</a:t>
            </a:r>
            <a:r>
              <a:rPr lang="en-US" sz="14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817617" y="3199641"/>
            <a:ext cx="1034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i="0" dirty="0" smtClean="0"/>
              <a:t>wild </a:t>
            </a:r>
            <a:r>
              <a:rPr lang="en-US" i="0" dirty="0"/>
              <a:t>typ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510581" y="1011400"/>
            <a:ext cx="2571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863475" y="1015654"/>
            <a:ext cx="2571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890847" y="3209926"/>
            <a:ext cx="7718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adrb1</a:t>
            </a:r>
            <a:r>
              <a:rPr lang="en-US" sz="14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283189" y="3209926"/>
            <a:ext cx="1034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i="0" dirty="0" smtClean="0"/>
              <a:t>wild </a:t>
            </a:r>
            <a:r>
              <a:rPr lang="en-US" i="0" dirty="0"/>
              <a:t>type</a:t>
            </a:r>
          </a:p>
        </p:txBody>
      </p:sp>
    </p:spTree>
    <p:extLst>
      <p:ext uri="{BB962C8B-B14F-4D97-AF65-F5344CB8AC3E}">
        <p14:creationId xmlns:p14="http://schemas.microsoft.com/office/powerpoint/2010/main" val="38971083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2826" y="1589059"/>
            <a:ext cx="3546611" cy="269470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215464" y="3682075"/>
            <a:ext cx="1224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,3-BDM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714936" y="3682075"/>
            <a:ext cx="1224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ntrol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2525315" y="2431023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7" name="Rectangle 6"/>
          <p:cNvSpPr/>
          <p:nvPr/>
        </p:nvSpPr>
        <p:spPr>
          <a:xfrm>
            <a:off x="1392827" y="566600"/>
            <a:ext cx="24765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2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477432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99" r="11753"/>
          <a:stretch/>
        </p:blipFill>
        <p:spPr>
          <a:xfrm rot="5400000" flipH="1">
            <a:off x="5135058" y="2194967"/>
            <a:ext cx="2878956" cy="422452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52" r="13265"/>
          <a:stretch/>
        </p:blipFill>
        <p:spPr>
          <a:xfrm rot="5400000" flipH="1">
            <a:off x="873251" y="2194264"/>
            <a:ext cx="2880361" cy="422452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3576" b="34607"/>
          <a:stretch/>
        </p:blipFill>
        <p:spPr>
          <a:xfrm>
            <a:off x="198120" y="1510134"/>
            <a:ext cx="4227576" cy="132588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546" b="25699"/>
          <a:stretch/>
        </p:blipFill>
        <p:spPr>
          <a:xfrm>
            <a:off x="4459224" y="1510134"/>
            <a:ext cx="4227576" cy="1323916"/>
          </a:xfrm>
          <a:prstGeom prst="rect">
            <a:avLst/>
          </a:prstGeom>
        </p:spPr>
      </p:pic>
      <p:cxnSp>
        <p:nvCxnSpPr>
          <p:cNvPr id="8" name="Straight Connector 7"/>
          <p:cNvCxnSpPr/>
          <p:nvPr/>
        </p:nvCxnSpPr>
        <p:spPr>
          <a:xfrm>
            <a:off x="7552944" y="5670111"/>
            <a:ext cx="1014152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7993909" y="2769594"/>
            <a:ext cx="601180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745674" y="1140802"/>
            <a:ext cx="1537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adrb1</a:t>
            </a:r>
            <a:r>
              <a:rPr lang="en-US" i="1" baseline="30000" dirty="0"/>
              <a:t>-/-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212378" y="1140802"/>
            <a:ext cx="1537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ild type</a:t>
            </a:r>
          </a:p>
        </p:txBody>
      </p:sp>
      <p:sp>
        <p:nvSpPr>
          <p:cNvPr id="7" name="Rectangle 6"/>
          <p:cNvSpPr/>
          <p:nvPr/>
        </p:nvSpPr>
        <p:spPr>
          <a:xfrm>
            <a:off x="365760" y="447712"/>
            <a:ext cx="863193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3. </a:t>
            </a:r>
            <a:endParaRPr lang="en-US" dirty="0"/>
          </a:p>
        </p:txBody>
      </p:sp>
      <p:sp>
        <p:nvSpPr>
          <p:cNvPr id="6" name="Right Bracket 5"/>
          <p:cNvSpPr/>
          <p:nvPr/>
        </p:nvSpPr>
        <p:spPr>
          <a:xfrm>
            <a:off x="2423162" y="4456254"/>
            <a:ext cx="109728" cy="1005840"/>
          </a:xfrm>
          <a:prstGeom prst="rightBracket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ight Bracket 16"/>
          <p:cNvSpPr/>
          <p:nvPr/>
        </p:nvSpPr>
        <p:spPr>
          <a:xfrm>
            <a:off x="6573012" y="4456254"/>
            <a:ext cx="129541" cy="938706"/>
          </a:xfrm>
          <a:prstGeom prst="rightBracket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ight Bracket 17"/>
          <p:cNvSpPr/>
          <p:nvPr/>
        </p:nvSpPr>
        <p:spPr>
          <a:xfrm>
            <a:off x="2505458" y="4230779"/>
            <a:ext cx="45719" cy="203776"/>
          </a:xfrm>
          <a:prstGeom prst="rightBracket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ight Bracket 18"/>
          <p:cNvSpPr/>
          <p:nvPr/>
        </p:nvSpPr>
        <p:spPr>
          <a:xfrm>
            <a:off x="6656835" y="4249068"/>
            <a:ext cx="45719" cy="185487"/>
          </a:xfrm>
          <a:prstGeom prst="rightBracket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4403530" y="1455270"/>
            <a:ext cx="2571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43537" y="1455270"/>
            <a:ext cx="2571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43536" y="2815762"/>
            <a:ext cx="2571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406303" y="2815762"/>
            <a:ext cx="2571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709198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5</TotalTime>
  <Words>291</Words>
  <Application>Microsoft Office PowerPoint</Application>
  <PresentationFormat>On-screen Show (4:3)</PresentationFormat>
  <Paragraphs>22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nqing</dc:creator>
  <cp:lastModifiedBy>wenqing</cp:lastModifiedBy>
  <cp:revision>10</cp:revision>
  <dcterms:created xsi:type="dcterms:W3CDTF">2024-05-05T07:30:55Z</dcterms:created>
  <dcterms:modified xsi:type="dcterms:W3CDTF">2024-05-06T05:26:39Z</dcterms:modified>
</cp:coreProperties>
</file>